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1304F8-AA9E-422F-932C-92C128C687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822DA8-4DB9-445C-B6CB-E05287C7092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8DD3BD-EE79-429E-A5B2-92FDE32E9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70565-7807-498E-8BE2-935587908776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3E41F0-D936-4133-9EE8-D9AA27EC7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7F6BA2-B200-4CB0-A3AA-43828F291C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5AA32-9B6A-4F85-A794-353AC590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757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682CAD-47A1-4E15-9CE9-D9167054DC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44C32D-D5D4-468D-8538-ECC3002303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E29628-877C-4239-B9F9-0F8CA222DD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70565-7807-498E-8BE2-935587908776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3AF270-A23E-4BDB-A46B-25FCA37604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A03BDC-BC03-4F62-8736-F8814857B1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5AA32-9B6A-4F85-A794-353AC590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408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27B716C-2A12-4402-ACA4-A629368D3E2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55B535-4B71-4B62-92B8-FFA7334F10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BEC8C9-883E-456B-BDC4-1BBC014317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70565-7807-498E-8BE2-935587908776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0C3B05-115C-4BBE-A816-968C10771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FC503D-EF5E-4056-9276-F5D1E43CA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5AA32-9B6A-4F85-A794-353AC590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18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BECCF3-F999-4872-8B14-686A7ED7E5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9261E5-6BB0-493E-B00B-BE1A03D57E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D84AC5-7D6A-482D-A6E8-5D8D46846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70565-7807-498E-8BE2-935587908776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23EFEF-F087-4204-9F20-43AA50860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726A8A-5E7D-41DA-9B0F-D7A1EBAAE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5AA32-9B6A-4F85-A794-353AC590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6378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0FBDE1-21ED-4F75-B8A0-DB8992AF99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8645DE-093D-4AF3-A08D-A042EC6811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365F46-FBF9-45AF-A93B-99AED298BB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70565-7807-498E-8BE2-935587908776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347857-0C17-446E-AC7F-7DCD3C977E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621908-8342-416C-9EF3-AC3F4BFC76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5AA32-9B6A-4F85-A794-353AC590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602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248A7C-57B2-41EF-862E-0DB435C8E0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E8EDC0-0D8D-4FC4-8EB4-79A860799E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994B57-9C41-48E4-8428-15B55F62B9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5FD034-64BF-45AE-B7A5-24933672ED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70565-7807-498E-8BE2-935587908776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396BC7-D0E0-4C66-B4A3-7332108276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040157-3145-44BC-A6CC-050AAB47B7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5AA32-9B6A-4F85-A794-353AC590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9984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2E4270-0477-47B9-825E-23E329D9C6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8B4801-2965-4776-B3BC-D1E5C0BECE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F4400F-401B-4629-8DEF-5372B24C9C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D05227F-D6D6-40BF-A531-DD84718771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23BA984-28CE-4905-BA8D-A5278C6351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6E275FB-A3A3-4786-8869-ADD055D62C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70565-7807-498E-8BE2-935587908776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14AA47-5BB5-40F1-8E41-3180B2F85F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DA09CBC-4363-43BF-ADF8-6C6338E9C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5AA32-9B6A-4F85-A794-353AC590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5147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73D79E-29FF-4ED4-B691-D5506186FB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79001E3-44A8-4339-92F6-E5B1ABB7D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70565-7807-498E-8BE2-935587908776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6165F20-E026-4888-9E57-9B2D5610AC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7F1B1A3-DE06-4195-8784-0256B7C7A6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5AA32-9B6A-4F85-A794-353AC590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851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A4BA945-8193-4B7B-A2BE-C8DB1CF9D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70565-7807-498E-8BE2-935587908776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F51807A-25B1-4A03-AE4C-3B1EA3B2D7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03AA9E0-1AF3-4865-B2D2-6DD20C5CA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5AA32-9B6A-4F85-A794-353AC590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807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BB6A54-E187-46FA-A846-6A7DB717D5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048674-D231-4DD6-84FB-BC58BA32A5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982D48-7FBA-4ACA-AFCC-8BC759BFA4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4A18B8-AB85-40B1-9A03-9561527915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70565-7807-498E-8BE2-935587908776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D3296A-9147-4182-9512-176E62DBEF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94BB8B-B936-42D5-B9E3-C861BF67B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5AA32-9B6A-4F85-A794-353AC590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387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7E1818-9A7C-4BBD-9C98-4A0E933E10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F2B208-6390-434D-80ED-1EE70939C9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358A99-6B77-4CB3-ABDE-60E83DFD67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C3EE8C-DBDD-4FB2-A71F-5FC54D702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70565-7807-498E-8BE2-935587908776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C180D6-9D62-425C-99F9-58BD00A39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F23ADA-38E3-4E2E-BC3E-1FFCA6DD4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5AA32-9B6A-4F85-A794-353AC590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719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74004C-42D9-4DF8-AAE9-15F9AEA3E7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ADCD93-1349-4E31-A296-C2C7B4DF8C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E40AD2-26DD-4645-9F90-82DED6A4A7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470565-7807-498E-8BE2-935587908776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31CC66-131F-437E-8237-E5E0C1DC84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49EE36-8D49-46AE-9622-0552F7EC49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55AA32-9B6A-4F85-A794-353AC590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03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s://caps-cpca.ubc.ca/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258A9F-EF24-4630-93B6-10EEDCDF611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96150"/>
            <a:ext cx="9144000" cy="2387600"/>
          </a:xfrm>
        </p:spPr>
        <p:txBody>
          <a:bodyPr>
            <a:normAutofit/>
          </a:bodyPr>
          <a:lstStyle/>
          <a:p>
            <a:br>
              <a:rPr lang="en-US" sz="5300" dirty="0"/>
            </a:br>
            <a:r>
              <a:rPr lang="en-US" sz="5400" dirty="0"/>
              <a:t>CAPS-CPCA</a:t>
            </a:r>
            <a:br>
              <a:rPr lang="en-US" sz="5300" dirty="0"/>
            </a:b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9BEB7A-EDFF-4413-82E6-DABD24EF5CE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r>
              <a:rPr lang="en-US" sz="4400" dirty="0"/>
              <a:t>Website Screenshots</a:t>
            </a:r>
          </a:p>
          <a:p>
            <a:r>
              <a:rPr lang="en-US" sz="2000" dirty="0">
                <a:hlinkClick r:id="rId2"/>
              </a:rPr>
              <a:t>https://caps-cpca.ubc.ca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2655488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Text&#10;&#10;Description automatically generated">
            <a:extLst>
              <a:ext uri="{FF2B5EF4-FFF2-40B4-BE49-F238E27FC236}">
                <a16:creationId xmlns:a16="http://schemas.microsoft.com/office/drawing/2014/main" id="{D434DA68-9859-418F-92EB-303433EEAA5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074" y="22049"/>
            <a:ext cx="10917663" cy="616688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1E173F3-BEE0-4700-ABB3-731A391F124C}"/>
              </a:ext>
            </a:extLst>
          </p:cNvPr>
          <p:cNvSpPr txBox="1"/>
          <p:nvPr/>
        </p:nvSpPr>
        <p:spPr>
          <a:xfrm>
            <a:off x="4672361" y="6088559"/>
            <a:ext cx="3216073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dirty="0"/>
              <a:t>Landing page</a:t>
            </a:r>
          </a:p>
        </p:txBody>
      </p:sp>
    </p:spTree>
    <p:extLst>
      <p:ext uri="{BB962C8B-B14F-4D97-AF65-F5344CB8AC3E}">
        <p14:creationId xmlns:p14="http://schemas.microsoft.com/office/powerpoint/2010/main" val="37956097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01E173F3-BEE0-4700-ABB3-731A391F124C}"/>
              </a:ext>
            </a:extLst>
          </p:cNvPr>
          <p:cNvSpPr txBox="1"/>
          <p:nvPr/>
        </p:nvSpPr>
        <p:spPr>
          <a:xfrm>
            <a:off x="4672361" y="6088559"/>
            <a:ext cx="4286302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dirty="0"/>
              <a:t>Helpful Resources</a:t>
            </a:r>
          </a:p>
        </p:txBody>
      </p:sp>
      <p:pic>
        <p:nvPicPr>
          <p:cNvPr id="3" name="Picture 2" descr="Graphical user interface, text&#10;&#10;Description automatically generated">
            <a:extLst>
              <a:ext uri="{FF2B5EF4-FFF2-40B4-BE49-F238E27FC236}">
                <a16:creationId xmlns:a16="http://schemas.microsoft.com/office/drawing/2014/main" id="{463E801D-EFEB-4F0D-9ACC-BB39E785D6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624" y="0"/>
            <a:ext cx="11094752" cy="62567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07380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01E173F3-BEE0-4700-ABB3-731A391F124C}"/>
              </a:ext>
            </a:extLst>
          </p:cNvPr>
          <p:cNvSpPr txBox="1"/>
          <p:nvPr/>
        </p:nvSpPr>
        <p:spPr>
          <a:xfrm>
            <a:off x="3534937" y="6188920"/>
            <a:ext cx="6580263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dirty="0"/>
              <a:t>Frequently Asked Questions</a:t>
            </a:r>
          </a:p>
        </p:txBody>
      </p:sp>
      <p:pic>
        <p:nvPicPr>
          <p:cNvPr id="4" name="Picture 3" descr="Graphical user interface, text, application&#10;&#10;Description automatically generated">
            <a:extLst>
              <a:ext uri="{FF2B5EF4-FFF2-40B4-BE49-F238E27FC236}">
                <a16:creationId xmlns:a16="http://schemas.microsoft.com/office/drawing/2014/main" id="{5891BE97-74B8-4ED0-98FB-550FF440B1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468" y="0"/>
            <a:ext cx="11241066" cy="63612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3184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01E173F3-BEE0-4700-ABB3-731A391F124C}"/>
              </a:ext>
            </a:extLst>
          </p:cNvPr>
          <p:cNvSpPr txBox="1"/>
          <p:nvPr/>
        </p:nvSpPr>
        <p:spPr>
          <a:xfrm>
            <a:off x="2286001" y="6200071"/>
            <a:ext cx="8437053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dirty="0"/>
              <a:t>What’s happening in your province?</a:t>
            </a:r>
          </a:p>
        </p:txBody>
      </p:sp>
      <p:pic>
        <p:nvPicPr>
          <p:cNvPr id="3" name="Picture 2" descr="Graphical user interface&#10;&#10;Description automatically generated">
            <a:extLst>
              <a:ext uri="{FF2B5EF4-FFF2-40B4-BE49-F238E27FC236}">
                <a16:creationId xmlns:a16="http://schemas.microsoft.com/office/drawing/2014/main" id="{BFA5588B-2E3E-4FE9-AA18-428AC6848D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224" y="0"/>
            <a:ext cx="11344507" cy="63510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65109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01E173F3-BEE0-4700-ABB3-731A391F124C}"/>
              </a:ext>
            </a:extLst>
          </p:cNvPr>
          <p:cNvSpPr txBox="1"/>
          <p:nvPr/>
        </p:nvSpPr>
        <p:spPr>
          <a:xfrm>
            <a:off x="4259767" y="6200071"/>
            <a:ext cx="4482317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dirty="0"/>
              <a:t>Locate a Pharmacy</a:t>
            </a:r>
          </a:p>
        </p:txBody>
      </p:sp>
      <p:pic>
        <p:nvPicPr>
          <p:cNvPr id="4" name="Picture 3" descr="Map&#10;&#10;Description automatically generated">
            <a:extLst>
              <a:ext uri="{FF2B5EF4-FFF2-40B4-BE49-F238E27FC236}">
                <a16:creationId xmlns:a16="http://schemas.microsoft.com/office/drawing/2014/main" id="{FEC87D13-7DE3-473D-98B4-4A91F82EAF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717" y="0"/>
            <a:ext cx="11422566" cy="63791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79542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28</Words>
  <Application>Microsoft Office PowerPoint</Application>
  <PresentationFormat>Widescreen</PresentationFormat>
  <Paragraphs>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 CAPS-CPCA 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nadian Abortion Provider Support – Communuate de pratique Canadienne sur l’avortement</dc:title>
  <dc:creator>Dunn, Sheila</dc:creator>
  <cp:lastModifiedBy>Dunn, Sheila</cp:lastModifiedBy>
  <cp:revision>3</cp:revision>
  <dcterms:created xsi:type="dcterms:W3CDTF">2022-03-18T15:45:04Z</dcterms:created>
  <dcterms:modified xsi:type="dcterms:W3CDTF">2022-03-18T16:13:12Z</dcterms:modified>
</cp:coreProperties>
</file>